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60" r:id="rId3"/>
    <p:sldId id="256" r:id="rId4"/>
    <p:sldId id="261" r:id="rId5"/>
    <p:sldId id="262" r:id="rId6"/>
    <p:sldId id="263" r:id="rId7"/>
  </p:sldIdLst>
  <p:sldSz cx="10655300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125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&#12460;&#12531;&#12510;H2AX&#12501;&#12457;&#12540;&#12459;&#12473;&#28204;&#2345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omey\Desktop\H2AX&#12501;&#12457;&#12540;&#12459;&#12473;\&#20104;&#24460;&#35519;&#26619;DNAPKH2AX221210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omey\Desktop\H2AX&#12501;&#12457;&#12540;&#12459;&#12473;\JRR%20Revise230731\Revise&#29992;&#20104;&#24460;&#35519;&#26619;H2AX23073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864588801399825"/>
          <c:y val="5.5891294838145242E-2"/>
          <c:w val="0.77913188976377956"/>
          <c:h val="0.7564927821522309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rgbClr val="FF0000"/>
                </a:solidFill>
                <a:prstDash val="dash"/>
              </a:ln>
              <a:effectLst/>
            </c:spPr>
            <c:trendlineType val="linear"/>
            <c:dispRSqr val="0"/>
            <c:dispEq val="0"/>
          </c:trendline>
          <c:xVal>
            <c:numRef>
              <c:f>結果まとめ!$A$4:$A$117</c:f>
              <c:numCache>
                <c:formatCode>General</c:formatCode>
                <c:ptCount val="11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  <c:pt idx="101">
                  <c:v>102</c:v>
                </c:pt>
                <c:pt idx="102">
                  <c:v>103</c:v>
                </c:pt>
                <c:pt idx="103">
                  <c:v>104</c:v>
                </c:pt>
                <c:pt idx="104">
                  <c:v>105</c:v>
                </c:pt>
                <c:pt idx="105">
                  <c:v>106</c:v>
                </c:pt>
                <c:pt idx="106">
                  <c:v>107</c:v>
                </c:pt>
                <c:pt idx="107">
                  <c:v>108</c:v>
                </c:pt>
                <c:pt idx="108">
                  <c:v>109</c:v>
                </c:pt>
                <c:pt idx="109">
                  <c:v>110</c:v>
                </c:pt>
                <c:pt idx="110">
                  <c:v>111</c:v>
                </c:pt>
                <c:pt idx="111">
                  <c:v>112</c:v>
                </c:pt>
                <c:pt idx="112">
                  <c:v>113</c:v>
                </c:pt>
                <c:pt idx="113">
                  <c:v>114</c:v>
                </c:pt>
              </c:numCache>
            </c:numRef>
          </c:xVal>
          <c:yVal>
            <c:numRef>
              <c:f>結果まとめ!$H$4:$H$117</c:f>
              <c:numCache>
                <c:formatCode>0.00_);[Red]\(0.00\)</c:formatCode>
                <c:ptCount val="114"/>
                <c:pt idx="0">
                  <c:v>0.61529808773903261</c:v>
                </c:pt>
                <c:pt idx="1">
                  <c:v>0.48371531966224368</c:v>
                </c:pt>
                <c:pt idx="2">
                  <c:v>0.54848800834202294</c:v>
                </c:pt>
                <c:pt idx="3">
                  <c:v>0.55011389521640097</c:v>
                </c:pt>
                <c:pt idx="4">
                  <c:v>0.51752336448598124</c:v>
                </c:pt>
                <c:pt idx="5">
                  <c:v>0.56605800214822766</c:v>
                </c:pt>
                <c:pt idx="6">
                  <c:v>0.6261160714285714</c:v>
                </c:pt>
                <c:pt idx="7">
                  <c:v>0.54585635359116025</c:v>
                </c:pt>
                <c:pt idx="8">
                  <c:v>0.56766055045871555</c:v>
                </c:pt>
                <c:pt idx="9">
                  <c:v>0.57651245551601427</c:v>
                </c:pt>
                <c:pt idx="10">
                  <c:v>0.5864661654135338</c:v>
                </c:pt>
                <c:pt idx="11">
                  <c:v>0.62093023255813951</c:v>
                </c:pt>
                <c:pt idx="12">
                  <c:v>0.57314148681055155</c:v>
                </c:pt>
                <c:pt idx="13">
                  <c:v>0.55494505494505497</c:v>
                </c:pt>
                <c:pt idx="14">
                  <c:v>0.5434782608695653</c:v>
                </c:pt>
                <c:pt idx="15">
                  <c:v>0.69964664310954061</c:v>
                </c:pt>
                <c:pt idx="16">
                  <c:v>0.69344608879492586</c:v>
                </c:pt>
                <c:pt idx="17">
                  <c:v>0.61555075593952491</c:v>
                </c:pt>
                <c:pt idx="18">
                  <c:v>0.68024691358024691</c:v>
                </c:pt>
                <c:pt idx="19">
                  <c:v>0.7363751584283903</c:v>
                </c:pt>
                <c:pt idx="20">
                  <c:v>0.54494382022471899</c:v>
                </c:pt>
                <c:pt idx="21">
                  <c:v>0.5518040717597259</c:v>
                </c:pt>
                <c:pt idx="22">
                  <c:v>0.67920353982300885</c:v>
                </c:pt>
                <c:pt idx="23">
                  <c:v>0.53469387755102038</c:v>
                </c:pt>
                <c:pt idx="24">
                  <c:v>0.53383458646616533</c:v>
                </c:pt>
                <c:pt idx="25">
                  <c:v>0.60662525879917184</c:v>
                </c:pt>
                <c:pt idx="26">
                  <c:v>0.549279538904899</c:v>
                </c:pt>
                <c:pt idx="27">
                  <c:v>0.50517598343685299</c:v>
                </c:pt>
                <c:pt idx="28">
                  <c:v>0.55567226890756305</c:v>
                </c:pt>
                <c:pt idx="29">
                  <c:v>0.5218295218295218</c:v>
                </c:pt>
                <c:pt idx="30">
                  <c:v>0.5133928571428571</c:v>
                </c:pt>
                <c:pt idx="31">
                  <c:v>0.60327455919395467</c:v>
                </c:pt>
                <c:pt idx="32">
                  <c:v>0.51898734177215189</c:v>
                </c:pt>
                <c:pt idx="33">
                  <c:v>0.50053022269353131</c:v>
                </c:pt>
                <c:pt idx="40">
                  <c:v>0.53040540540540537</c:v>
                </c:pt>
                <c:pt idx="42">
                  <c:v>0.51638418079096049</c:v>
                </c:pt>
                <c:pt idx="43">
                  <c:v>0.56570713391739669</c:v>
                </c:pt>
                <c:pt idx="44">
                  <c:v>0.51868629671574185</c:v>
                </c:pt>
                <c:pt idx="45">
                  <c:v>0.58851113716295422</c:v>
                </c:pt>
                <c:pt idx="46">
                  <c:v>0.59145673603504922</c:v>
                </c:pt>
                <c:pt idx="47">
                  <c:v>0.62857142857142856</c:v>
                </c:pt>
                <c:pt idx="48">
                  <c:v>0.57958287596048308</c:v>
                </c:pt>
                <c:pt idx="49">
                  <c:v>0.65609756097560978</c:v>
                </c:pt>
                <c:pt idx="50">
                  <c:v>0.60020986358866735</c:v>
                </c:pt>
                <c:pt idx="51">
                  <c:v>0.66327683615819211</c:v>
                </c:pt>
                <c:pt idx="52">
                  <c:v>0.6465067778936392</c:v>
                </c:pt>
                <c:pt idx="54">
                  <c:v>0.65328874024526196</c:v>
                </c:pt>
                <c:pt idx="55">
                  <c:v>0.63366336633663367</c:v>
                </c:pt>
                <c:pt idx="56">
                  <c:v>0.68496158068057089</c:v>
                </c:pt>
                <c:pt idx="58">
                  <c:v>0.56619144602851323</c:v>
                </c:pt>
                <c:pt idx="59">
                  <c:v>0.60997963340122197</c:v>
                </c:pt>
                <c:pt idx="60">
                  <c:v>0.70031880977683314</c:v>
                </c:pt>
                <c:pt idx="61">
                  <c:v>0.63794983642311887</c:v>
                </c:pt>
                <c:pt idx="62">
                  <c:v>0.60103626943005173</c:v>
                </c:pt>
                <c:pt idx="63">
                  <c:v>0.53276955602536991</c:v>
                </c:pt>
                <c:pt idx="64">
                  <c:v>0.62906504065040658</c:v>
                </c:pt>
                <c:pt idx="65">
                  <c:v>0.65333333333333332</c:v>
                </c:pt>
                <c:pt idx="66">
                  <c:v>0.51059322033898313</c:v>
                </c:pt>
                <c:pt idx="67">
                  <c:v>0.56999999999999995</c:v>
                </c:pt>
                <c:pt idx="68">
                  <c:v>0.54526091586794456</c:v>
                </c:pt>
                <c:pt idx="69">
                  <c:v>0.53496115427303004</c:v>
                </c:pt>
                <c:pt idx="70">
                  <c:v>0.59016393442622961</c:v>
                </c:pt>
                <c:pt idx="71">
                  <c:v>0.52332657200811361</c:v>
                </c:pt>
                <c:pt idx="72">
                  <c:v>0.57050592034445646</c:v>
                </c:pt>
                <c:pt idx="73">
                  <c:v>0.59090909090909094</c:v>
                </c:pt>
                <c:pt idx="74">
                  <c:v>0.60105820105820107</c:v>
                </c:pt>
                <c:pt idx="75">
                  <c:v>0.56048834628190902</c:v>
                </c:pt>
                <c:pt idx="76">
                  <c:v>0.54806739345887023</c:v>
                </c:pt>
                <c:pt idx="77">
                  <c:v>0.56924643584521384</c:v>
                </c:pt>
                <c:pt idx="78">
                  <c:v>0.6070686070686071</c:v>
                </c:pt>
                <c:pt idx="79">
                  <c:v>0.59185918591859188</c:v>
                </c:pt>
                <c:pt idx="80">
                  <c:v>0.54212091179385524</c:v>
                </c:pt>
                <c:pt idx="82">
                  <c:v>0.56955645161290325</c:v>
                </c:pt>
                <c:pt idx="83">
                  <c:v>0.55676209279368205</c:v>
                </c:pt>
                <c:pt idx="84">
                  <c:v>0.56529036589459547</c:v>
                </c:pt>
                <c:pt idx="86">
                  <c:v>0.54864593781344029</c:v>
                </c:pt>
                <c:pt idx="87">
                  <c:v>0.60216216216216223</c:v>
                </c:pt>
                <c:pt idx="88">
                  <c:v>0.64206268958543977</c:v>
                </c:pt>
                <c:pt idx="89">
                  <c:v>0.57981462409886708</c:v>
                </c:pt>
                <c:pt idx="90">
                  <c:v>0.60312500000000002</c:v>
                </c:pt>
                <c:pt idx="91">
                  <c:v>0.6606189967982925</c:v>
                </c:pt>
                <c:pt idx="93">
                  <c:v>0.51622718052738337</c:v>
                </c:pt>
                <c:pt idx="94">
                  <c:v>0.58594594594594596</c:v>
                </c:pt>
                <c:pt idx="95">
                  <c:v>0.5082604470359573</c:v>
                </c:pt>
                <c:pt idx="96">
                  <c:v>0.58402971216341693</c:v>
                </c:pt>
                <c:pt idx="97">
                  <c:v>0.61375661375661383</c:v>
                </c:pt>
                <c:pt idx="98">
                  <c:v>0.64348785871964675</c:v>
                </c:pt>
                <c:pt idx="100">
                  <c:v>0.53627450980392155</c:v>
                </c:pt>
                <c:pt idx="101">
                  <c:v>0.6328708644610459</c:v>
                </c:pt>
                <c:pt idx="104">
                  <c:v>0.51153460381143423</c:v>
                </c:pt>
                <c:pt idx="105">
                  <c:v>0.5562700964630225</c:v>
                </c:pt>
                <c:pt idx="106">
                  <c:v>0.55302279484638261</c:v>
                </c:pt>
                <c:pt idx="108">
                  <c:v>0.60141271442986877</c:v>
                </c:pt>
                <c:pt idx="109">
                  <c:v>0.63309352517985606</c:v>
                </c:pt>
                <c:pt idx="111">
                  <c:v>0.59778225806451613</c:v>
                </c:pt>
                <c:pt idx="112">
                  <c:v>0.5307317073170732</c:v>
                </c:pt>
                <c:pt idx="113">
                  <c:v>0.563230605738575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349-4D62-9AE0-72030BCA34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23231328"/>
        <c:axId val="623231656"/>
      </c:scatterChart>
      <c:valAx>
        <c:axId val="623231328"/>
        <c:scaling>
          <c:orientation val="minMax"/>
          <c:max val="12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3231656"/>
        <c:crosses val="autoZero"/>
        <c:crossBetween val="midCat"/>
        <c:majorUnit val="20"/>
      </c:valAx>
      <c:valAx>
        <c:axId val="623231656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3231328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8.1745510735439578E-2"/>
          <c:w val="0.8340298546629682"/>
          <c:h val="0.77070563883422849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O$3:$O$39</c:f>
              <c:numCache>
                <c:formatCode>General</c:formatCode>
                <c:ptCount val="37"/>
                <c:pt idx="0">
                  <c:v>2</c:v>
                </c:pt>
                <c:pt idx="1">
                  <c:v>2</c:v>
                </c:pt>
                <c:pt idx="2">
                  <c:v>2</c:v>
                </c:pt>
                <c:pt idx="3">
                  <c:v>3</c:v>
                </c:pt>
                <c:pt idx="4">
                  <c:v>1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1</c:v>
                </c:pt>
                <c:pt idx="9">
                  <c:v>3</c:v>
                </c:pt>
                <c:pt idx="10">
                  <c:v>2</c:v>
                </c:pt>
                <c:pt idx="11">
                  <c:v>2</c:v>
                </c:pt>
                <c:pt idx="12">
                  <c:v>1</c:v>
                </c:pt>
                <c:pt idx="13">
                  <c:v>2</c:v>
                </c:pt>
                <c:pt idx="14">
                  <c:v>2</c:v>
                </c:pt>
                <c:pt idx="15">
                  <c:v>1</c:v>
                </c:pt>
                <c:pt idx="16">
                  <c:v>2</c:v>
                </c:pt>
                <c:pt idx="17">
                  <c:v>1</c:v>
                </c:pt>
                <c:pt idx="18">
                  <c:v>2</c:v>
                </c:pt>
                <c:pt idx="19">
                  <c:v>1</c:v>
                </c:pt>
                <c:pt idx="20">
                  <c:v>2</c:v>
                </c:pt>
                <c:pt idx="21">
                  <c:v>2</c:v>
                </c:pt>
                <c:pt idx="22">
                  <c:v>1</c:v>
                </c:pt>
                <c:pt idx="23">
                  <c:v>2</c:v>
                </c:pt>
                <c:pt idx="24">
                  <c:v>1</c:v>
                </c:pt>
                <c:pt idx="25">
                  <c:v>1</c:v>
                </c:pt>
                <c:pt idx="26">
                  <c:v>1</c:v>
                </c:pt>
                <c:pt idx="27">
                  <c:v>1</c:v>
                </c:pt>
                <c:pt idx="28">
                  <c:v>2</c:v>
                </c:pt>
                <c:pt idx="29">
                  <c:v>1</c:v>
                </c:pt>
                <c:pt idx="30">
                  <c:v>0</c:v>
                </c:pt>
                <c:pt idx="31">
                  <c:v>1</c:v>
                </c:pt>
                <c:pt idx="32">
                  <c:v>0</c:v>
                </c:pt>
                <c:pt idx="33">
                  <c:v>1</c:v>
                </c:pt>
                <c:pt idx="34">
                  <c:v>0</c:v>
                </c:pt>
                <c:pt idx="35">
                  <c:v>0</c:v>
                </c:pt>
                <c:pt idx="36">
                  <c:v>2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E37-4EC2-BC57-8E79820C4785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O$40:$O$4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1</c:v>
                </c:pt>
                <c:pt idx="7">
                  <c:v>2</c:v>
                </c:pt>
                <c:pt idx="8">
                  <c:v>0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E37-4EC2-BC57-8E79820C47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4"/>
          <c:min val="-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At val="-1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67481561834231"/>
          <c:y val="7.8466021141650674E-2"/>
          <c:w val="0.79124990494983183"/>
          <c:h val="0.79250562448302797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A$45</c:f>
              <c:strCache>
                <c:ptCount val="1"/>
                <c:pt idx="0">
                  <c:v>repair rate</c:v>
                </c:pt>
              </c:strCache>
            </c:strRef>
          </c:tx>
          <c:spPr>
            <a:ln>
              <a:solidFill>
                <a:srgbClr val="000080"/>
              </a:solidFill>
              <a:prstDash val="solid"/>
            </a:ln>
          </c:spPr>
          <c:marker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xVal>
            <c:numRef>
              <c:f>Sheet2!$B$47:$B$91</c:f>
              <c:numCache>
                <c:formatCode>0.0000</c:formatCode>
                <c:ptCount val="45"/>
                <c:pt idx="0">
                  <c:v>1</c:v>
                </c:pt>
                <c:pt idx="1">
                  <c:v>0.97142857142857142</c:v>
                </c:pt>
                <c:pt idx="2">
                  <c:v>0.94285714285714284</c:v>
                </c:pt>
                <c:pt idx="3">
                  <c:v>0.91428571428571426</c:v>
                </c:pt>
                <c:pt idx="4">
                  <c:v>0.88571428571428568</c:v>
                </c:pt>
                <c:pt idx="5">
                  <c:v>0.8571428571428571</c:v>
                </c:pt>
                <c:pt idx="6">
                  <c:v>0.82857142857142863</c:v>
                </c:pt>
                <c:pt idx="7">
                  <c:v>0.8</c:v>
                </c:pt>
                <c:pt idx="8">
                  <c:v>0.77142857142857146</c:v>
                </c:pt>
                <c:pt idx="9">
                  <c:v>0.74285714285714288</c:v>
                </c:pt>
                <c:pt idx="10">
                  <c:v>0.7142857142857143</c:v>
                </c:pt>
                <c:pt idx="11">
                  <c:v>0.68571428571428572</c:v>
                </c:pt>
                <c:pt idx="12">
                  <c:v>0.65714285714285714</c:v>
                </c:pt>
                <c:pt idx="13">
                  <c:v>0.62857142857142856</c:v>
                </c:pt>
                <c:pt idx="14">
                  <c:v>0.6</c:v>
                </c:pt>
                <c:pt idx="15">
                  <c:v>0.5714285714285714</c:v>
                </c:pt>
                <c:pt idx="16">
                  <c:v>0.54285714285714282</c:v>
                </c:pt>
                <c:pt idx="17">
                  <c:v>0.54285714285714282</c:v>
                </c:pt>
                <c:pt idx="18">
                  <c:v>0.51428571428571423</c:v>
                </c:pt>
                <c:pt idx="19">
                  <c:v>0.48571428571428571</c:v>
                </c:pt>
                <c:pt idx="20">
                  <c:v>0.45714285714285713</c:v>
                </c:pt>
                <c:pt idx="21">
                  <c:v>0.45714285714285713</c:v>
                </c:pt>
                <c:pt idx="22">
                  <c:v>0.42857142857142855</c:v>
                </c:pt>
                <c:pt idx="23">
                  <c:v>0.4</c:v>
                </c:pt>
                <c:pt idx="24">
                  <c:v>0.4</c:v>
                </c:pt>
                <c:pt idx="25">
                  <c:v>0.4</c:v>
                </c:pt>
                <c:pt idx="26">
                  <c:v>0.37142857142857144</c:v>
                </c:pt>
                <c:pt idx="27">
                  <c:v>0.31428571428571428</c:v>
                </c:pt>
                <c:pt idx="28">
                  <c:v>0.31428571428571428</c:v>
                </c:pt>
                <c:pt idx="29">
                  <c:v>0.2857142857142857</c:v>
                </c:pt>
                <c:pt idx="30">
                  <c:v>0.25714285714285712</c:v>
                </c:pt>
                <c:pt idx="31">
                  <c:v>0.25714285714285712</c:v>
                </c:pt>
                <c:pt idx="32">
                  <c:v>0.22857142857142856</c:v>
                </c:pt>
                <c:pt idx="33">
                  <c:v>0.22857142857142856</c:v>
                </c:pt>
                <c:pt idx="34">
                  <c:v>0.2</c:v>
                </c:pt>
                <c:pt idx="35">
                  <c:v>0.17142857142857143</c:v>
                </c:pt>
                <c:pt idx="36">
                  <c:v>0.14285714285714285</c:v>
                </c:pt>
                <c:pt idx="37">
                  <c:v>0.11428571428571428</c:v>
                </c:pt>
                <c:pt idx="38">
                  <c:v>8.5714285714285715E-2</c:v>
                </c:pt>
                <c:pt idx="39">
                  <c:v>5.7142857142857141E-2</c:v>
                </c:pt>
                <c:pt idx="40">
                  <c:v>5.7142857142857141E-2</c:v>
                </c:pt>
                <c:pt idx="41">
                  <c:v>2.8571428571428571E-2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</c:numCache>
            </c:numRef>
          </c:xVal>
          <c:yVal>
            <c:numRef>
              <c:f>Sheet2!$C$47:$C$91</c:f>
              <c:numCache>
                <c:formatCode>0.0000</c:formatCode>
                <c:ptCount val="4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0.90909090909090906</c:v>
                </c:pt>
                <c:pt idx="18">
                  <c:v>0.90909090909090906</c:v>
                </c:pt>
                <c:pt idx="19">
                  <c:v>0.90909090909090906</c:v>
                </c:pt>
                <c:pt idx="20">
                  <c:v>0.90909090909090906</c:v>
                </c:pt>
                <c:pt idx="21">
                  <c:v>0.81818181818181823</c:v>
                </c:pt>
                <c:pt idx="22">
                  <c:v>0.81818181818181823</c:v>
                </c:pt>
                <c:pt idx="23">
                  <c:v>0.81818181818181823</c:v>
                </c:pt>
                <c:pt idx="24">
                  <c:v>0.72727272727272729</c:v>
                </c:pt>
                <c:pt idx="25">
                  <c:v>0.63636363636363635</c:v>
                </c:pt>
                <c:pt idx="26">
                  <c:v>0.63636363636363635</c:v>
                </c:pt>
                <c:pt idx="27">
                  <c:v>0.54545454545454541</c:v>
                </c:pt>
                <c:pt idx="28">
                  <c:v>0.45454545454545453</c:v>
                </c:pt>
                <c:pt idx="29">
                  <c:v>0.45454545454545453</c:v>
                </c:pt>
                <c:pt idx="30">
                  <c:v>0.45454545454545453</c:v>
                </c:pt>
                <c:pt idx="31">
                  <c:v>0.36363636363636365</c:v>
                </c:pt>
                <c:pt idx="32">
                  <c:v>0.36363636363636365</c:v>
                </c:pt>
                <c:pt idx="33">
                  <c:v>0.27272727272727271</c:v>
                </c:pt>
                <c:pt idx="34">
                  <c:v>0.27272727272727271</c:v>
                </c:pt>
                <c:pt idx="35">
                  <c:v>0.27272727272727271</c:v>
                </c:pt>
                <c:pt idx="36">
                  <c:v>0.27272727272727271</c:v>
                </c:pt>
                <c:pt idx="37">
                  <c:v>0.27272727272727271</c:v>
                </c:pt>
                <c:pt idx="38">
                  <c:v>0.27272727272727271</c:v>
                </c:pt>
                <c:pt idx="39">
                  <c:v>0.27272727272727271</c:v>
                </c:pt>
                <c:pt idx="40">
                  <c:v>0.18181818181818182</c:v>
                </c:pt>
                <c:pt idx="41">
                  <c:v>0.18181818181818182</c:v>
                </c:pt>
                <c:pt idx="42">
                  <c:v>0.18181818181818182</c:v>
                </c:pt>
                <c:pt idx="43">
                  <c:v>9.0909090909090912E-2</c:v>
                </c:pt>
                <c:pt idx="44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A5E-407E-837B-CF5582639F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7481631"/>
        <c:axId val="581235727"/>
      </c:scatterChart>
      <c:valAx>
        <c:axId val="577481631"/>
        <c:scaling>
          <c:orientation val="minMax"/>
          <c:max val="1"/>
          <c:min val="0"/>
        </c:scaling>
        <c:delete val="0"/>
        <c:axPos val="b"/>
        <c:numFmt formatCode="General" sourceLinked="0"/>
        <c:majorTickMark val="in"/>
        <c:minorTickMark val="none"/>
        <c:tickLblPos val="nextTo"/>
        <c:spPr>
          <a:ln/>
        </c:spPr>
        <c:txPr>
          <a:bodyPr/>
          <a:lstStyle/>
          <a:p>
            <a:pPr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81235727"/>
        <c:crosses val="autoZero"/>
        <c:crossBetween val="midCat"/>
        <c:majorUnit val="0.2"/>
      </c:valAx>
      <c:valAx>
        <c:axId val="581235727"/>
        <c:scaling>
          <c:orientation val="minMax"/>
          <c:max val="1"/>
          <c:min val="0"/>
        </c:scaling>
        <c:delete val="0"/>
        <c:axPos val="l"/>
        <c:numFmt formatCode="General" sourceLinked="0"/>
        <c:majorTickMark val="in"/>
        <c:minorTickMark val="none"/>
        <c:tickLblPos val="nextTo"/>
        <c:spPr>
          <a:ln/>
        </c:spPr>
        <c:txPr>
          <a:bodyPr/>
          <a:lstStyle/>
          <a:p>
            <a:pPr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577481631"/>
        <c:crosses val="autoZero"/>
        <c:crossBetween val="midCat"/>
        <c:majorUnit val="0.2"/>
      </c:valAx>
      <c:spPr>
        <a:noFill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413274380483542"/>
          <c:y val="0.322342580245012"/>
          <c:w val="0.66227930512481692"/>
          <c:h val="0.35436810116114237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G$3:$G$39</c:f>
              <c:numCache>
                <c:formatCode>General</c:formatCode>
                <c:ptCount val="37"/>
                <c:pt idx="0">
                  <c:v>1550</c:v>
                </c:pt>
                <c:pt idx="1">
                  <c:v>910</c:v>
                </c:pt>
                <c:pt idx="2">
                  <c:v>2400</c:v>
                </c:pt>
                <c:pt idx="3">
                  <c:v>1120</c:v>
                </c:pt>
                <c:pt idx="4">
                  <c:v>2230</c:v>
                </c:pt>
                <c:pt idx="5">
                  <c:v>962</c:v>
                </c:pt>
                <c:pt idx="6">
                  <c:v>364</c:v>
                </c:pt>
                <c:pt idx="7">
                  <c:v>931</c:v>
                </c:pt>
                <c:pt idx="8">
                  <c:v>1340</c:v>
                </c:pt>
                <c:pt idx="9">
                  <c:v>524</c:v>
                </c:pt>
                <c:pt idx="10">
                  <c:v>802</c:v>
                </c:pt>
                <c:pt idx="11">
                  <c:v>664</c:v>
                </c:pt>
                <c:pt idx="12">
                  <c:v>699</c:v>
                </c:pt>
                <c:pt idx="13">
                  <c:v>128</c:v>
                </c:pt>
                <c:pt idx="14">
                  <c:v>1050</c:v>
                </c:pt>
                <c:pt idx="15">
                  <c:v>740</c:v>
                </c:pt>
                <c:pt idx="16">
                  <c:v>290</c:v>
                </c:pt>
                <c:pt idx="17">
                  <c:v>446</c:v>
                </c:pt>
                <c:pt idx="18">
                  <c:v>462</c:v>
                </c:pt>
                <c:pt idx="19">
                  <c:v>1063</c:v>
                </c:pt>
                <c:pt idx="20">
                  <c:v>950</c:v>
                </c:pt>
                <c:pt idx="21">
                  <c:v>2085</c:v>
                </c:pt>
                <c:pt idx="22">
                  <c:v>1206</c:v>
                </c:pt>
                <c:pt idx="23">
                  <c:v>487</c:v>
                </c:pt>
                <c:pt idx="24">
                  <c:v>611</c:v>
                </c:pt>
                <c:pt idx="25">
                  <c:v>1233</c:v>
                </c:pt>
                <c:pt idx="26">
                  <c:v>507</c:v>
                </c:pt>
                <c:pt idx="27">
                  <c:v>972</c:v>
                </c:pt>
                <c:pt idx="28">
                  <c:v>365</c:v>
                </c:pt>
                <c:pt idx="29">
                  <c:v>1246</c:v>
                </c:pt>
                <c:pt idx="30">
                  <c:v>1227</c:v>
                </c:pt>
                <c:pt idx="31">
                  <c:v>3774</c:v>
                </c:pt>
                <c:pt idx="32">
                  <c:v>1100</c:v>
                </c:pt>
                <c:pt idx="33">
                  <c:v>1067</c:v>
                </c:pt>
                <c:pt idx="34">
                  <c:v>1176</c:v>
                </c:pt>
                <c:pt idx="35">
                  <c:v>2134</c:v>
                </c:pt>
                <c:pt idx="36">
                  <c:v>1178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67D-40B2-A738-88756262CF06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3!$G$40:$G$48</c:f>
              <c:numCache>
                <c:formatCode>General</c:formatCode>
                <c:ptCount val="9"/>
                <c:pt idx="0">
                  <c:v>1850</c:v>
                </c:pt>
                <c:pt idx="1">
                  <c:v>1984</c:v>
                </c:pt>
                <c:pt idx="2">
                  <c:v>1235</c:v>
                </c:pt>
                <c:pt idx="3">
                  <c:v>1505</c:v>
                </c:pt>
                <c:pt idx="4">
                  <c:v>3002</c:v>
                </c:pt>
                <c:pt idx="5">
                  <c:v>1056</c:v>
                </c:pt>
                <c:pt idx="6">
                  <c:v>2176</c:v>
                </c:pt>
                <c:pt idx="7">
                  <c:v>3863</c:v>
                </c:pt>
                <c:pt idx="8">
                  <c:v>2125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67D-40B2-A738-88756262CF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0527600"/>
        <c:axId val="800959552"/>
      </c:scatterChart>
      <c:valAx>
        <c:axId val="800527600"/>
        <c:scaling>
          <c:orientation val="minMax"/>
          <c:max val="50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_);[Red]\(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9552"/>
        <c:crosses val="autoZero"/>
        <c:crossBetween val="midCat"/>
        <c:majorUnit val="1000"/>
      </c:valAx>
      <c:valAx>
        <c:axId val="800959552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527600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45755955617658"/>
          <c:y val="0.15636313169811134"/>
          <c:w val="0.80061753345027353"/>
          <c:h val="0.52453193276392773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I$3:$I$39</c:f>
              <c:numCache>
                <c:formatCode>General</c:formatCode>
                <c:ptCount val="37"/>
                <c:pt idx="0">
                  <c:v>140</c:v>
                </c:pt>
                <c:pt idx="1">
                  <c:v>180</c:v>
                </c:pt>
                <c:pt idx="2">
                  <c:v>464</c:v>
                </c:pt>
                <c:pt idx="3">
                  <c:v>460</c:v>
                </c:pt>
                <c:pt idx="4">
                  <c:v>210</c:v>
                </c:pt>
                <c:pt idx="5">
                  <c:v>182</c:v>
                </c:pt>
                <c:pt idx="6">
                  <c:v>101</c:v>
                </c:pt>
                <c:pt idx="7">
                  <c:v>243</c:v>
                </c:pt>
                <c:pt idx="8">
                  <c:v>300</c:v>
                </c:pt>
                <c:pt idx="9">
                  <c:v>173</c:v>
                </c:pt>
                <c:pt idx="10">
                  <c:v>175</c:v>
                </c:pt>
                <c:pt idx="11">
                  <c:v>82</c:v>
                </c:pt>
                <c:pt idx="12">
                  <c:v>140</c:v>
                </c:pt>
                <c:pt idx="13">
                  <c:v>141</c:v>
                </c:pt>
                <c:pt idx="14">
                  <c:v>210</c:v>
                </c:pt>
                <c:pt idx="15">
                  <c:v>73</c:v>
                </c:pt>
                <c:pt idx="16">
                  <c:v>164</c:v>
                </c:pt>
                <c:pt idx="17">
                  <c:v>260</c:v>
                </c:pt>
                <c:pt idx="18">
                  <c:v>164</c:v>
                </c:pt>
                <c:pt idx="19">
                  <c:v>235</c:v>
                </c:pt>
                <c:pt idx="20">
                  <c:v>333</c:v>
                </c:pt>
                <c:pt idx="21">
                  <c:v>200</c:v>
                </c:pt>
                <c:pt idx="22">
                  <c:v>311</c:v>
                </c:pt>
                <c:pt idx="23">
                  <c:v>262</c:v>
                </c:pt>
                <c:pt idx="24">
                  <c:v>358</c:v>
                </c:pt>
                <c:pt idx="25">
                  <c:v>159</c:v>
                </c:pt>
                <c:pt idx="26">
                  <c:v>250</c:v>
                </c:pt>
                <c:pt idx="27">
                  <c:v>79</c:v>
                </c:pt>
                <c:pt idx="28">
                  <c:v>94</c:v>
                </c:pt>
                <c:pt idx="29">
                  <c:v>342</c:v>
                </c:pt>
                <c:pt idx="30">
                  <c:v>140</c:v>
                </c:pt>
                <c:pt idx="31">
                  <c:v>93</c:v>
                </c:pt>
                <c:pt idx="32">
                  <c:v>139</c:v>
                </c:pt>
                <c:pt idx="33">
                  <c:v>111</c:v>
                </c:pt>
                <c:pt idx="34">
                  <c:v>179</c:v>
                </c:pt>
                <c:pt idx="35">
                  <c:v>400</c:v>
                </c:pt>
                <c:pt idx="36">
                  <c:v>325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BC1-42FB-A7A4-2F3D01FBF973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heet3!$I$40:$I$48</c:f>
              <c:numCache>
                <c:formatCode>General</c:formatCode>
                <c:ptCount val="9"/>
                <c:pt idx="0">
                  <c:v>638</c:v>
                </c:pt>
                <c:pt idx="1">
                  <c:v>290</c:v>
                </c:pt>
                <c:pt idx="2">
                  <c:v>317</c:v>
                </c:pt>
                <c:pt idx="3">
                  <c:v>673</c:v>
                </c:pt>
                <c:pt idx="4">
                  <c:v>418</c:v>
                </c:pt>
                <c:pt idx="5">
                  <c:v>226</c:v>
                </c:pt>
                <c:pt idx="6">
                  <c:v>323</c:v>
                </c:pt>
                <c:pt idx="7">
                  <c:v>189</c:v>
                </c:pt>
                <c:pt idx="8">
                  <c:v>495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BC1-42FB-A7A4-2F3D01FBF9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0527600"/>
        <c:axId val="800959552"/>
      </c:scatterChart>
      <c:valAx>
        <c:axId val="800527600"/>
        <c:scaling>
          <c:orientation val="minMax"/>
          <c:max val="80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_);[Red]\(#,##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9552"/>
        <c:crosses val="autoZero"/>
        <c:crossBetween val="midCat"/>
        <c:majorUnit val="100"/>
      </c:valAx>
      <c:valAx>
        <c:axId val="800959552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527600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0.12409582399519399"/>
          <c:w val="0.8340298546629682"/>
          <c:h val="0.72835537506165926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J$3:$J$39</c:f>
              <c:numCache>
                <c:formatCode>General</c:formatCode>
                <c:ptCount val="37"/>
                <c:pt idx="0">
                  <c:v>4</c:v>
                </c:pt>
                <c:pt idx="1">
                  <c:v>4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3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3</c:v>
                </c:pt>
                <c:pt idx="15">
                  <c:v>4</c:v>
                </c:pt>
                <c:pt idx="16">
                  <c:v>4</c:v>
                </c:pt>
                <c:pt idx="17">
                  <c:v>3</c:v>
                </c:pt>
                <c:pt idx="18">
                  <c:v>4</c:v>
                </c:pt>
                <c:pt idx="19">
                  <c:v>3</c:v>
                </c:pt>
                <c:pt idx="20">
                  <c:v>3</c:v>
                </c:pt>
                <c:pt idx="21">
                  <c:v>3</c:v>
                </c:pt>
                <c:pt idx="22">
                  <c:v>3</c:v>
                </c:pt>
                <c:pt idx="23">
                  <c:v>3</c:v>
                </c:pt>
                <c:pt idx="24">
                  <c:v>3</c:v>
                </c:pt>
                <c:pt idx="25">
                  <c:v>4</c:v>
                </c:pt>
                <c:pt idx="26">
                  <c:v>3</c:v>
                </c:pt>
                <c:pt idx="27">
                  <c:v>4</c:v>
                </c:pt>
                <c:pt idx="28">
                  <c:v>4</c:v>
                </c:pt>
                <c:pt idx="29">
                  <c:v>3</c:v>
                </c:pt>
                <c:pt idx="30">
                  <c:v>4</c:v>
                </c:pt>
                <c:pt idx="31">
                  <c:v>4</c:v>
                </c:pt>
                <c:pt idx="32">
                  <c:v>4</c:v>
                </c:pt>
                <c:pt idx="33">
                  <c:v>4</c:v>
                </c:pt>
                <c:pt idx="34">
                  <c:v>4</c:v>
                </c:pt>
                <c:pt idx="35">
                  <c:v>3</c:v>
                </c:pt>
                <c:pt idx="36">
                  <c:v>3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A93-4B23-ADD5-F9FADF569BA9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J$40:$J$48</c:f>
              <c:numCache>
                <c:formatCode>General</c:formatCode>
                <c:ptCount val="9"/>
                <c:pt idx="0">
                  <c:v>2</c:v>
                </c:pt>
                <c:pt idx="1">
                  <c:v>3</c:v>
                </c:pt>
                <c:pt idx="2">
                  <c:v>3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  <c:pt idx="7">
                  <c:v>4</c:v>
                </c:pt>
                <c:pt idx="8">
                  <c:v>3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A93-4B23-ADD5-F9FADF569B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5"/>
          <c:min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 val="autoZero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8.1745510735439578E-2"/>
          <c:w val="0.8340298546629682"/>
          <c:h val="0.77070563883422849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H$3:$H$39</c:f>
              <c:numCache>
                <c:formatCode>General</c:formatCode>
                <c:ptCount val="37"/>
                <c:pt idx="0">
                  <c:v>1</c:v>
                </c:pt>
                <c:pt idx="1">
                  <c:v>3</c:v>
                </c:pt>
                <c:pt idx="2">
                  <c:v>0</c:v>
                </c:pt>
                <c:pt idx="3">
                  <c:v>2</c:v>
                </c:pt>
                <c:pt idx="4">
                  <c:v>0</c:v>
                </c:pt>
                <c:pt idx="5">
                  <c:v>3</c:v>
                </c:pt>
                <c:pt idx="6">
                  <c:v>4</c:v>
                </c:pt>
                <c:pt idx="7">
                  <c:v>3</c:v>
                </c:pt>
                <c:pt idx="8">
                  <c:v>2</c:v>
                </c:pt>
                <c:pt idx="9">
                  <c:v>3</c:v>
                </c:pt>
                <c:pt idx="10">
                  <c:v>3</c:v>
                </c:pt>
                <c:pt idx="11">
                  <c:v>3</c:v>
                </c:pt>
                <c:pt idx="12">
                  <c:v>3</c:v>
                </c:pt>
                <c:pt idx="13">
                  <c:v>4</c:v>
                </c:pt>
                <c:pt idx="14">
                  <c:v>2</c:v>
                </c:pt>
                <c:pt idx="15">
                  <c:v>3</c:v>
                </c:pt>
                <c:pt idx="16">
                  <c:v>4</c:v>
                </c:pt>
                <c:pt idx="17">
                  <c:v>4</c:v>
                </c:pt>
                <c:pt idx="18">
                  <c:v>4</c:v>
                </c:pt>
                <c:pt idx="19">
                  <c:v>2</c:v>
                </c:pt>
                <c:pt idx="20">
                  <c:v>3</c:v>
                </c:pt>
                <c:pt idx="21">
                  <c:v>0</c:v>
                </c:pt>
                <c:pt idx="22">
                  <c:v>2</c:v>
                </c:pt>
                <c:pt idx="23">
                  <c:v>4</c:v>
                </c:pt>
                <c:pt idx="24">
                  <c:v>3</c:v>
                </c:pt>
                <c:pt idx="25">
                  <c:v>2</c:v>
                </c:pt>
                <c:pt idx="26">
                  <c:v>3</c:v>
                </c:pt>
                <c:pt idx="27">
                  <c:v>3</c:v>
                </c:pt>
                <c:pt idx="28">
                  <c:v>4</c:v>
                </c:pt>
                <c:pt idx="29">
                  <c:v>2</c:v>
                </c:pt>
                <c:pt idx="30">
                  <c:v>2</c:v>
                </c:pt>
                <c:pt idx="31">
                  <c:v>0</c:v>
                </c:pt>
                <c:pt idx="32">
                  <c:v>2</c:v>
                </c:pt>
                <c:pt idx="33">
                  <c:v>2</c:v>
                </c:pt>
                <c:pt idx="34">
                  <c:v>2</c:v>
                </c:pt>
                <c:pt idx="35">
                  <c:v>0</c:v>
                </c:pt>
                <c:pt idx="36">
                  <c:v>2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9CC-4834-92F5-877607D7515A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H$40:$H$48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2</c:v>
                </c:pt>
                <c:pt idx="3">
                  <c:v>1</c:v>
                </c:pt>
                <c:pt idx="4">
                  <c:v>0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9CC-4834-92F5-877607D751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5"/>
          <c:min val="-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At val="-1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8.1745510735439578E-2"/>
          <c:w val="0.8340298546629682"/>
          <c:h val="0.77070563883422849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M$3:$M$39</c:f>
              <c:numCache>
                <c:formatCode>General</c:formatCode>
                <c:ptCount val="37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1</c:v>
                </c:pt>
                <c:pt idx="15">
                  <c:v>2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2</c:v>
                </c:pt>
                <c:pt idx="22">
                  <c:v>1</c:v>
                </c:pt>
                <c:pt idx="23">
                  <c:v>1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2</c:v>
                </c:pt>
                <c:pt idx="29">
                  <c:v>0</c:v>
                </c:pt>
                <c:pt idx="30">
                  <c:v>0</c:v>
                </c:pt>
                <c:pt idx="31">
                  <c:v>2</c:v>
                </c:pt>
                <c:pt idx="32">
                  <c:v>2</c:v>
                </c:pt>
                <c:pt idx="33">
                  <c:v>2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D1A-42ED-9A66-7A9E259BABC8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M$40:$M$4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D1A-42ED-9A66-7A9E259BAB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3"/>
          <c:min val="-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At val="-1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8.1745510735439578E-2"/>
          <c:w val="0.8340298546629682"/>
          <c:h val="0.77070563883422849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L$3:$L$39</c:f>
              <c:numCache>
                <c:formatCode>General</c:formatCode>
                <c:ptCount val="37"/>
                <c:pt idx="0">
                  <c:v>0</c:v>
                </c:pt>
                <c:pt idx="1">
                  <c:v>2</c:v>
                </c:pt>
                <c:pt idx="2">
                  <c:v>0</c:v>
                </c:pt>
                <c:pt idx="3">
                  <c:v>0</c:v>
                </c:pt>
                <c:pt idx="4">
                  <c:v>3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3</c:v>
                </c:pt>
                <c:pt idx="10">
                  <c:v>2</c:v>
                </c:pt>
                <c:pt idx="11">
                  <c:v>3</c:v>
                </c:pt>
                <c:pt idx="12">
                  <c:v>0</c:v>
                </c:pt>
                <c:pt idx="13">
                  <c:v>4</c:v>
                </c:pt>
                <c:pt idx="14">
                  <c:v>2</c:v>
                </c:pt>
                <c:pt idx="15">
                  <c:v>0</c:v>
                </c:pt>
                <c:pt idx="16">
                  <c:v>3</c:v>
                </c:pt>
                <c:pt idx="17">
                  <c:v>2</c:v>
                </c:pt>
                <c:pt idx="18">
                  <c:v>3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2</c:v>
                </c:pt>
                <c:pt idx="23">
                  <c:v>2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2</c:v>
                </c:pt>
                <c:pt idx="28">
                  <c:v>2</c:v>
                </c:pt>
                <c:pt idx="29">
                  <c:v>3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2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D07-4A67-9000-E89C8E992109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L$40:$L$4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D07-4A67-9000-E89C8E99210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5"/>
          <c:min val="-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At val="-1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406713534962794"/>
          <c:y val="8.1745510735439578E-2"/>
          <c:w val="0.8340298546629682"/>
          <c:h val="0.77070563883422849"/>
        </c:manualLayout>
      </c:layout>
      <c:scatterChart>
        <c:scatterStyle val="lineMarker"/>
        <c:varyColors val="0"/>
        <c:ser>
          <c:idx val="0"/>
          <c:order val="0"/>
          <c:tx>
            <c:v>CC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noFill/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Q$3:$Q$39</c:f>
              <c:numCache>
                <c:formatCode>General</c:formatCode>
                <c:ptCount val="37"/>
                <c:pt idx="0">
                  <c:v>1</c:v>
                </c:pt>
                <c:pt idx="1">
                  <c:v>2</c:v>
                </c:pt>
                <c:pt idx="2">
                  <c:v>1</c:v>
                </c:pt>
                <c:pt idx="3">
                  <c:v>2</c:v>
                </c:pt>
                <c:pt idx="4">
                  <c:v>2</c:v>
                </c:pt>
                <c:pt idx="5">
                  <c:v>1</c:v>
                </c:pt>
                <c:pt idx="6">
                  <c:v>2</c:v>
                </c:pt>
                <c:pt idx="8">
                  <c:v>2</c:v>
                </c:pt>
                <c:pt idx="9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2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0</c:v>
                </c:pt>
                <c:pt idx="19">
                  <c:v>0</c:v>
                </c:pt>
                <c:pt idx="20">
                  <c:v>2</c:v>
                </c:pt>
                <c:pt idx="23">
                  <c:v>2</c:v>
                </c:pt>
                <c:pt idx="24">
                  <c:v>0</c:v>
                </c:pt>
                <c:pt idx="25">
                  <c:v>1</c:v>
                </c:pt>
                <c:pt idx="26">
                  <c:v>0</c:v>
                </c:pt>
                <c:pt idx="28">
                  <c:v>2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1</c:v>
                </c:pt>
                <c:pt idx="33">
                  <c:v>0</c:v>
                </c:pt>
                <c:pt idx="34">
                  <c:v>1</c:v>
                </c:pt>
                <c:pt idx="35">
                  <c:v>1</c:v>
                </c:pt>
                <c:pt idx="36">
                  <c:v>1</c:v>
                </c:pt>
              </c:numCache>
            </c:numRef>
          </c:xVal>
          <c:yVal>
            <c:numRef>
              <c:f>Sheet3!$B$3:$B$39</c:f>
              <c:numCache>
                <c:formatCode>0.00_);[Red]\(0.00\)</c:formatCode>
                <c:ptCount val="37"/>
                <c:pt idx="0">
                  <c:v>0.63794983642311887</c:v>
                </c:pt>
                <c:pt idx="1">
                  <c:v>0.63</c:v>
                </c:pt>
                <c:pt idx="2">
                  <c:v>0.53496115427303004</c:v>
                </c:pt>
                <c:pt idx="3">
                  <c:v>0.61555075593952491</c:v>
                </c:pt>
                <c:pt idx="4">
                  <c:v>0.54585635359116025</c:v>
                </c:pt>
                <c:pt idx="5">
                  <c:v>0.56999999999999995</c:v>
                </c:pt>
                <c:pt idx="6">
                  <c:v>0.56924643584521384</c:v>
                </c:pt>
                <c:pt idx="7">
                  <c:v>0.7363751584283903</c:v>
                </c:pt>
                <c:pt idx="8">
                  <c:v>0.6465067778936392</c:v>
                </c:pt>
                <c:pt idx="9">
                  <c:v>0.56605800214822766</c:v>
                </c:pt>
                <c:pt idx="10">
                  <c:v>0.69344608879492586</c:v>
                </c:pt>
                <c:pt idx="11">
                  <c:v>0.68024691358024691</c:v>
                </c:pt>
                <c:pt idx="12">
                  <c:v>0.55567226890756305</c:v>
                </c:pt>
                <c:pt idx="13">
                  <c:v>0.59145673603504922</c:v>
                </c:pt>
                <c:pt idx="14">
                  <c:v>0.65609756097560978</c:v>
                </c:pt>
                <c:pt idx="15">
                  <c:v>0.6606189967982925</c:v>
                </c:pt>
                <c:pt idx="16">
                  <c:v>0.64348785871964675</c:v>
                </c:pt>
                <c:pt idx="17">
                  <c:v>0.5562700964630225</c:v>
                </c:pt>
                <c:pt idx="18">
                  <c:v>0.6</c:v>
                </c:pt>
                <c:pt idx="19">
                  <c:v>0.54848800834202294</c:v>
                </c:pt>
                <c:pt idx="20">
                  <c:v>0.60327455919395467</c:v>
                </c:pt>
                <c:pt idx="21">
                  <c:v>0.6</c:v>
                </c:pt>
                <c:pt idx="22">
                  <c:v>0.60105820105820107</c:v>
                </c:pt>
                <c:pt idx="23">
                  <c:v>0.5218295218295218</c:v>
                </c:pt>
                <c:pt idx="24">
                  <c:v>0.53040540540540537</c:v>
                </c:pt>
                <c:pt idx="25">
                  <c:v>0.58851113716295422</c:v>
                </c:pt>
                <c:pt idx="26">
                  <c:v>0.62857142857142856</c:v>
                </c:pt>
                <c:pt idx="27">
                  <c:v>0.65333333333333332</c:v>
                </c:pt>
                <c:pt idx="28">
                  <c:v>0.59090909090909094</c:v>
                </c:pt>
                <c:pt idx="29">
                  <c:v>0.56048834628190902</c:v>
                </c:pt>
                <c:pt idx="30">
                  <c:v>0.54806739345887023</c:v>
                </c:pt>
                <c:pt idx="31">
                  <c:v>0.59185918591859188</c:v>
                </c:pt>
                <c:pt idx="32">
                  <c:v>0.54212091179385524</c:v>
                </c:pt>
                <c:pt idx="33">
                  <c:v>0.54864593781344029</c:v>
                </c:pt>
                <c:pt idx="34">
                  <c:v>0.58402971216341693</c:v>
                </c:pt>
                <c:pt idx="35">
                  <c:v>0.51153460381143423</c:v>
                </c:pt>
                <c:pt idx="36">
                  <c:v>0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242-4709-9DB8-5E47BB09360E}"/>
            </c:ext>
          </c:extLst>
        </c:ser>
        <c:ser>
          <c:idx val="1"/>
          <c:order val="1"/>
          <c:tx>
            <c:v>RT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1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xVal>
            <c:numRef>
              <c:f>Sheet3!$Q$40:$Q$4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</c:numCache>
            </c:numRef>
          </c:xVal>
          <c:yVal>
            <c:numRef>
              <c:f>Sheet3!$B$40:$B$48</c:f>
              <c:numCache>
                <c:formatCode>0.00_);[Red]\(0.00\)</c:formatCode>
                <c:ptCount val="9"/>
                <c:pt idx="0">
                  <c:v>0.5518040717597259</c:v>
                </c:pt>
                <c:pt idx="1">
                  <c:v>0.56570713391739669</c:v>
                </c:pt>
                <c:pt idx="2">
                  <c:v>0.57958287596048308</c:v>
                </c:pt>
                <c:pt idx="3">
                  <c:v>0.56619144602851323</c:v>
                </c:pt>
                <c:pt idx="4">
                  <c:v>0.70031880977683314</c:v>
                </c:pt>
                <c:pt idx="5">
                  <c:v>0.60103626943005173</c:v>
                </c:pt>
                <c:pt idx="6">
                  <c:v>0.6070686070686071</c:v>
                </c:pt>
                <c:pt idx="7">
                  <c:v>0.55676209279368205</c:v>
                </c:pt>
                <c:pt idx="8">
                  <c:v>0.585945945945945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242-4709-9DB8-5E47BB0936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7347088"/>
        <c:axId val="800953728"/>
      </c:scatterChart>
      <c:valAx>
        <c:axId val="527347088"/>
        <c:scaling>
          <c:orientation val="minMax"/>
          <c:max val="3"/>
          <c:min val="-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800953728"/>
        <c:crosses val="autoZero"/>
        <c:crossBetween val="midCat"/>
        <c:majorUnit val="1"/>
      </c:valAx>
      <c:valAx>
        <c:axId val="800953728"/>
        <c:scaling>
          <c:orientation val="minMax"/>
          <c:max val="0.8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,##0.0_);[Red]\(#,##0.0\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27347088"/>
        <c:crossesAt val="-1"/>
        <c:crossBetween val="midCat"/>
        <c:majorUnit val="0.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2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99148" y="1237197"/>
            <a:ext cx="9057005" cy="2631887"/>
          </a:xfrm>
        </p:spPr>
        <p:txBody>
          <a:bodyPr anchor="b"/>
          <a:lstStyle>
            <a:lvl1pPr algn="ctr"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31913" y="3970580"/>
            <a:ext cx="7991475" cy="1825171"/>
          </a:xfrm>
        </p:spPr>
        <p:txBody>
          <a:bodyPr/>
          <a:lstStyle>
            <a:lvl1pPr marL="0" indent="0" algn="ctr">
              <a:buNone/>
              <a:defRPr sz="2646"/>
            </a:lvl1pPr>
            <a:lvl2pPr marL="503972" indent="0" algn="ctr">
              <a:buNone/>
              <a:defRPr sz="2205"/>
            </a:lvl2pPr>
            <a:lvl3pPr marL="1007943" indent="0" algn="ctr">
              <a:buNone/>
              <a:defRPr sz="1984"/>
            </a:lvl3pPr>
            <a:lvl4pPr marL="1511915" indent="0" algn="ctr">
              <a:buNone/>
              <a:defRPr sz="1764"/>
            </a:lvl4pPr>
            <a:lvl5pPr marL="2015886" indent="0" algn="ctr">
              <a:buNone/>
              <a:defRPr sz="1764"/>
            </a:lvl5pPr>
            <a:lvl6pPr marL="2519858" indent="0" algn="ctr">
              <a:buNone/>
              <a:defRPr sz="1764"/>
            </a:lvl6pPr>
            <a:lvl7pPr marL="3023829" indent="0" algn="ctr">
              <a:buNone/>
              <a:defRPr sz="1764"/>
            </a:lvl7pPr>
            <a:lvl8pPr marL="3527801" indent="0" algn="ctr">
              <a:buNone/>
              <a:defRPr sz="1764"/>
            </a:lvl8pPr>
            <a:lvl9pPr marL="4031772" indent="0" algn="ctr">
              <a:buNone/>
              <a:defRPr sz="176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040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83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625200" y="402483"/>
            <a:ext cx="2297549" cy="640647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2552" y="402483"/>
            <a:ext cx="6759456" cy="640647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3028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786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7003" y="1884671"/>
            <a:ext cx="9190196" cy="3144614"/>
          </a:xfrm>
        </p:spPr>
        <p:txBody>
          <a:bodyPr anchor="b"/>
          <a:lstStyle>
            <a:lvl1pPr>
              <a:defRPr sz="661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7003" y="5059035"/>
            <a:ext cx="9190196" cy="1653678"/>
          </a:xfrm>
        </p:spPr>
        <p:txBody>
          <a:bodyPr/>
          <a:lstStyle>
            <a:lvl1pPr marL="0" indent="0">
              <a:buNone/>
              <a:defRPr sz="2646">
                <a:solidFill>
                  <a:schemeClr val="tx1"/>
                </a:solidFill>
              </a:defRPr>
            </a:lvl1pPr>
            <a:lvl2pPr marL="503972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757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2552" y="2012414"/>
            <a:ext cx="4528503" cy="47965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94245" y="2012414"/>
            <a:ext cx="4528503" cy="47965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0560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3940" y="402484"/>
            <a:ext cx="9190196" cy="146118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3941" y="1853171"/>
            <a:ext cx="4507691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3941" y="2761381"/>
            <a:ext cx="4507691" cy="40615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394246" y="1853171"/>
            <a:ext cx="4529890" cy="908210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394246" y="2761381"/>
            <a:ext cx="4529890" cy="40615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87835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9235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3660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3940" y="503978"/>
            <a:ext cx="343661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29890" y="1088455"/>
            <a:ext cx="5394246" cy="5372269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3940" y="2267902"/>
            <a:ext cx="343661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0172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3940" y="503978"/>
            <a:ext cx="3436612" cy="1763924"/>
          </a:xfrm>
        </p:spPr>
        <p:txBody>
          <a:bodyPr anchor="b"/>
          <a:lstStyle>
            <a:lvl1pPr>
              <a:defRPr sz="352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29890" y="1088455"/>
            <a:ext cx="5394246" cy="5372269"/>
          </a:xfrm>
        </p:spPr>
        <p:txBody>
          <a:bodyPr anchor="t"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33940" y="2267902"/>
            <a:ext cx="3436612" cy="4201570"/>
          </a:xfrm>
        </p:spPr>
        <p:txBody>
          <a:bodyPr/>
          <a:lstStyle>
            <a:lvl1pPr marL="0" indent="0">
              <a:buNone/>
              <a:defRPr sz="1764"/>
            </a:lvl1pPr>
            <a:lvl2pPr marL="503972" indent="0">
              <a:buNone/>
              <a:defRPr sz="1543"/>
            </a:lvl2pPr>
            <a:lvl3pPr marL="1007943" indent="0">
              <a:buNone/>
              <a:defRPr sz="1323"/>
            </a:lvl3pPr>
            <a:lvl4pPr marL="1511915" indent="0">
              <a:buNone/>
              <a:defRPr sz="1102"/>
            </a:lvl4pPr>
            <a:lvl5pPr marL="2015886" indent="0">
              <a:buNone/>
              <a:defRPr sz="1102"/>
            </a:lvl5pPr>
            <a:lvl6pPr marL="2519858" indent="0">
              <a:buNone/>
              <a:defRPr sz="1102"/>
            </a:lvl6pPr>
            <a:lvl7pPr marL="3023829" indent="0">
              <a:buNone/>
              <a:defRPr sz="1102"/>
            </a:lvl7pPr>
            <a:lvl8pPr marL="3527801" indent="0">
              <a:buNone/>
              <a:defRPr sz="1102"/>
            </a:lvl8pPr>
            <a:lvl9pPr marL="4031772" indent="0">
              <a:buNone/>
              <a:defRPr sz="1102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249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2552" y="402484"/>
            <a:ext cx="9190196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2552" y="2012414"/>
            <a:ext cx="9190196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32552" y="7006700"/>
            <a:ext cx="2397443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07514-09A2-494C-B4D8-54B48B1B3114}" type="datetimeFigureOut">
              <a:rPr kumimoji="1" lang="ja-JP" altLang="en-US" smtClean="0"/>
              <a:t>2023/9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29568" y="7006700"/>
            <a:ext cx="3596164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525305" y="7006700"/>
            <a:ext cx="2397443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34802-6CF4-47CD-8A49-FD31D03BC3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395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7943" rtl="0" eaLnBrk="1" latinLnBrk="0" hangingPunct="1">
        <a:lnSpc>
          <a:spcPct val="90000"/>
        </a:lnSpc>
        <a:spcBef>
          <a:spcPct val="0"/>
        </a:spcBef>
        <a:buNone/>
        <a:defRPr kumimoji="1"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986" indent="-251986" algn="l" defTabSz="1007943" rtl="0" eaLnBrk="1" latinLnBrk="0" hangingPunct="1">
        <a:lnSpc>
          <a:spcPct val="90000"/>
        </a:lnSpc>
        <a:spcBef>
          <a:spcPts val="1102"/>
        </a:spcBef>
        <a:buFont typeface="Arial" panose="020B0604020202020204" pitchFamily="34" charset="0"/>
        <a:buChar char="•"/>
        <a:defRPr kumimoji="1" sz="3086" kern="1200">
          <a:solidFill>
            <a:schemeClr val="tx1"/>
          </a:solidFill>
          <a:latin typeface="+mn-lt"/>
          <a:ea typeface="+mn-ea"/>
          <a:cs typeface="+mn-cs"/>
        </a:defRPr>
      </a:lvl1pPr>
      <a:lvl2pPr marL="75595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64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2205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lnSpc>
          <a:spcPct val="90000"/>
        </a:lnSpc>
        <a:spcBef>
          <a:spcPts val="551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06007F8-3FED-41F2-990D-E8D8E2E8C87A}"/>
              </a:ext>
            </a:extLst>
          </p:cNvPr>
          <p:cNvSpPr txBox="1"/>
          <p:nvPr/>
        </p:nvSpPr>
        <p:spPr>
          <a:xfrm>
            <a:off x="1292947" y="1132904"/>
            <a:ext cx="3259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グラフ 20">
            <a:extLst>
              <a:ext uri="{FF2B5EF4-FFF2-40B4-BE49-F238E27FC236}">
                <a16:creationId xmlns:a16="http://schemas.microsoft.com/office/drawing/2014/main" id="{5E5B1B70-D61E-44F6-8EAB-4C77252EF2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6246919"/>
              </p:ext>
            </p:extLst>
          </p:nvPr>
        </p:nvGraphicFramePr>
        <p:xfrm>
          <a:off x="3218513" y="240823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E102F51-1B99-4287-AA0F-04909982F749}"/>
              </a:ext>
            </a:extLst>
          </p:cNvPr>
          <p:cNvSpPr txBox="1"/>
          <p:nvPr/>
        </p:nvSpPr>
        <p:spPr>
          <a:xfrm>
            <a:off x="5504513" y="1995994"/>
            <a:ext cx="1940979" cy="400110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4hr/30min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29E8A7A2-DECF-4B76-A49A-62604861A942}"/>
              </a:ext>
            </a:extLst>
          </p:cNvPr>
          <p:cNvSpPr txBox="1"/>
          <p:nvPr/>
        </p:nvSpPr>
        <p:spPr>
          <a:xfrm>
            <a:off x="4833961" y="5151437"/>
            <a:ext cx="17988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 number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1104F78-8FF0-4F19-9616-329B93BE530D}"/>
              </a:ext>
            </a:extLst>
          </p:cNvPr>
          <p:cNvSpPr txBox="1"/>
          <p:nvPr/>
        </p:nvSpPr>
        <p:spPr>
          <a:xfrm rot="16200000">
            <a:off x="2015528" y="3317721"/>
            <a:ext cx="18341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ci decay ratio</a:t>
            </a:r>
            <a:endParaRPr kumimoji="1"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35276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A9BD8E-B306-4A66-AAEF-F03B84CCD04A}"/>
              </a:ext>
            </a:extLst>
          </p:cNvPr>
          <p:cNvSpPr txBox="1"/>
          <p:nvPr/>
        </p:nvSpPr>
        <p:spPr>
          <a:xfrm>
            <a:off x="820647" y="257733"/>
            <a:ext cx="33361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</a:p>
        </p:txBody>
      </p:sp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63831EBC-7D47-445F-A7B4-3AADD9B616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1048760"/>
              </p:ext>
            </p:extLst>
          </p:nvPr>
        </p:nvGraphicFramePr>
        <p:xfrm>
          <a:off x="1947636" y="1284515"/>
          <a:ext cx="6825343" cy="56932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楕円 4">
            <a:extLst>
              <a:ext uri="{FF2B5EF4-FFF2-40B4-BE49-F238E27FC236}">
                <a16:creationId xmlns:a16="http://schemas.microsoft.com/office/drawing/2014/main" id="{0D37C554-B35C-47E1-BA0D-501C57477D51}"/>
              </a:ext>
            </a:extLst>
          </p:cNvPr>
          <p:cNvSpPr/>
          <p:nvPr/>
        </p:nvSpPr>
        <p:spPr>
          <a:xfrm>
            <a:off x="4765212" y="2427517"/>
            <a:ext cx="252000" cy="252000"/>
          </a:xfrm>
          <a:prstGeom prst="ellipse">
            <a:avLst/>
          </a:prstGeom>
          <a:noFill/>
          <a:ln w="317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45DFC77-C7FF-4245-BE9F-8FB9BB58DFE2}"/>
              </a:ext>
            </a:extLst>
          </p:cNvPr>
          <p:cNvSpPr txBox="1"/>
          <p:nvPr/>
        </p:nvSpPr>
        <p:spPr>
          <a:xfrm>
            <a:off x="4352324" y="6915916"/>
            <a:ext cx="203773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Specificity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876D0B3-8A75-45F2-B77B-65830AF8814B}"/>
              </a:ext>
            </a:extLst>
          </p:cNvPr>
          <p:cNvSpPr txBox="1"/>
          <p:nvPr/>
        </p:nvSpPr>
        <p:spPr>
          <a:xfrm rot="16200000">
            <a:off x="685512" y="3705519"/>
            <a:ext cx="171874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84EBD21-2E99-4AD6-9BE9-AA927C9B3ECE}"/>
              </a:ext>
            </a:extLst>
          </p:cNvPr>
          <p:cNvSpPr txBox="1"/>
          <p:nvPr/>
        </p:nvSpPr>
        <p:spPr>
          <a:xfrm>
            <a:off x="6338946" y="3014156"/>
            <a:ext cx="311168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t-off value = 0.59</a:t>
            </a:r>
          </a:p>
          <a:p>
            <a:r>
              <a:rPr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 = 0.727</a:t>
            </a:r>
            <a:endParaRPr kumimoji="1" lang="en-US" altLang="ja-JP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1555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15C95BFA-B024-47B1-9A5E-CB91CF3C6311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269527" y="336865"/>
          <a:ext cx="5385773" cy="60703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77188A6D-0376-428F-B045-1D3644CED89C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36718" y="1549814"/>
          <a:ext cx="4586958" cy="43016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C535BE8-92FC-4897-A56A-C21D5A250AC7}"/>
              </a:ext>
            </a:extLst>
          </p:cNvPr>
          <p:cNvSpPr txBox="1"/>
          <p:nvPr/>
        </p:nvSpPr>
        <p:spPr>
          <a:xfrm rot="16200000">
            <a:off x="-997325" y="3235889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34E8E14-F4FD-4232-8634-E503AFD6ED94}"/>
              </a:ext>
            </a:extLst>
          </p:cNvPr>
          <p:cNvSpPr txBox="1"/>
          <p:nvPr/>
        </p:nvSpPr>
        <p:spPr>
          <a:xfrm>
            <a:off x="209053" y="1526508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9222FD3-0DDB-44D5-A44F-9F0E4517F776}"/>
              </a:ext>
            </a:extLst>
          </p:cNvPr>
          <p:cNvSpPr/>
          <p:nvPr/>
        </p:nvSpPr>
        <p:spPr>
          <a:xfrm>
            <a:off x="322907" y="5070011"/>
            <a:ext cx="516679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um lymphocyte count during treatmen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/mm3)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50A8328-7DDB-41BD-AEB0-CCB1863CD184}"/>
              </a:ext>
            </a:extLst>
          </p:cNvPr>
          <p:cNvSpPr txBox="1"/>
          <p:nvPr/>
        </p:nvSpPr>
        <p:spPr>
          <a:xfrm rot="16200000">
            <a:off x="4417957" y="3235889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96F99AA-AE23-4C59-B2C9-085C4E31D63A}"/>
              </a:ext>
            </a:extLst>
          </p:cNvPr>
          <p:cNvSpPr txBox="1"/>
          <p:nvPr/>
        </p:nvSpPr>
        <p:spPr>
          <a:xfrm>
            <a:off x="5323675" y="1526509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6B32BEC8-618B-42EA-AD4D-E5D9DD435FBA}"/>
              </a:ext>
            </a:extLst>
          </p:cNvPr>
          <p:cNvSpPr/>
          <p:nvPr/>
        </p:nvSpPr>
        <p:spPr>
          <a:xfrm>
            <a:off x="5595544" y="5070011"/>
            <a:ext cx="512832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um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 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unt during treatment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/mm3)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3BE6B12-A18D-4891-9C78-FD314E852036}"/>
              </a:ext>
            </a:extLst>
          </p:cNvPr>
          <p:cNvSpPr txBox="1"/>
          <p:nvPr/>
        </p:nvSpPr>
        <p:spPr>
          <a:xfrm>
            <a:off x="4093800" y="2166497"/>
            <a:ext cx="1068498" cy="64633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4AB79E67-48C5-4C2A-B7E9-640AFA2D7234}"/>
              </a:ext>
            </a:extLst>
          </p:cNvPr>
          <p:cNvCxnSpPr/>
          <p:nvPr/>
        </p:nvCxnSpPr>
        <p:spPr>
          <a:xfrm>
            <a:off x="1641987" y="3460955"/>
            <a:ext cx="2821858" cy="609600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475940CA-ED17-44EC-BEB8-C3CBBCBF18E1}"/>
              </a:ext>
            </a:extLst>
          </p:cNvPr>
          <p:cNvCxnSpPr>
            <a:cxnSpLocks/>
          </p:cNvCxnSpPr>
          <p:nvPr/>
        </p:nvCxnSpPr>
        <p:spPr>
          <a:xfrm>
            <a:off x="6743927" y="3460955"/>
            <a:ext cx="2685208" cy="641219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814841C8-2306-4B5B-AE16-0836FFE1F03C}"/>
              </a:ext>
            </a:extLst>
          </p:cNvPr>
          <p:cNvSpPr/>
          <p:nvPr/>
        </p:nvSpPr>
        <p:spPr>
          <a:xfrm>
            <a:off x="9223642" y="1496640"/>
            <a:ext cx="110318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157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98</a:t>
            </a: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E5FB4293-FB2C-4C97-BC03-806E0D318052}"/>
              </a:ext>
            </a:extLst>
          </p:cNvPr>
          <p:cNvSpPr/>
          <p:nvPr/>
        </p:nvSpPr>
        <p:spPr>
          <a:xfrm>
            <a:off x="4083531" y="1377691"/>
            <a:ext cx="110318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 = -0.184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222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4C0E8B4-626C-4CFC-BFD5-24F63E6639F9}"/>
              </a:ext>
            </a:extLst>
          </p:cNvPr>
          <p:cNvSpPr txBox="1"/>
          <p:nvPr/>
        </p:nvSpPr>
        <p:spPr>
          <a:xfrm>
            <a:off x="9240986" y="2189137"/>
            <a:ext cx="1068498" cy="64633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D8EC729-6970-4EDB-B1D9-E6A65DDDCF93}"/>
              </a:ext>
            </a:extLst>
          </p:cNvPr>
          <p:cNvSpPr txBox="1"/>
          <p:nvPr/>
        </p:nvSpPr>
        <p:spPr>
          <a:xfrm>
            <a:off x="820647" y="257733"/>
            <a:ext cx="3259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19802318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A9BD8E-B306-4A66-AAEF-F03B84CCD04A}"/>
              </a:ext>
            </a:extLst>
          </p:cNvPr>
          <p:cNvSpPr txBox="1"/>
          <p:nvPr/>
        </p:nvSpPr>
        <p:spPr>
          <a:xfrm>
            <a:off x="820647" y="257733"/>
            <a:ext cx="32592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</a:p>
        </p:txBody>
      </p:sp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09A3B965-8BB0-4A95-B8CA-22665F25E3F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266317"/>
              </p:ext>
            </p:extLst>
          </p:nvPr>
        </p:nvGraphicFramePr>
        <p:xfrm>
          <a:off x="635052" y="1818961"/>
          <a:ext cx="4448226" cy="38984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A483255-919A-488C-A4E2-133EFEBB82D8}"/>
              </a:ext>
            </a:extLst>
          </p:cNvPr>
          <p:cNvSpPr txBox="1"/>
          <p:nvPr/>
        </p:nvSpPr>
        <p:spPr>
          <a:xfrm rot="16200000">
            <a:off x="-948676" y="3458122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000784-DC8C-4B28-99D1-3DA747ECE237}"/>
              </a:ext>
            </a:extLst>
          </p:cNvPr>
          <p:cNvSpPr txBox="1"/>
          <p:nvPr/>
        </p:nvSpPr>
        <p:spPr>
          <a:xfrm>
            <a:off x="209053" y="1526508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2D31979-B2B6-43FB-A39B-FE141B182F98}"/>
              </a:ext>
            </a:extLst>
          </p:cNvPr>
          <p:cNvSpPr/>
          <p:nvPr/>
        </p:nvSpPr>
        <p:spPr>
          <a:xfrm>
            <a:off x="1071716" y="5261239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9157449-3CDA-46E8-A41E-DA9DD584B071}"/>
              </a:ext>
            </a:extLst>
          </p:cNvPr>
          <p:cNvSpPr/>
          <p:nvPr/>
        </p:nvSpPr>
        <p:spPr>
          <a:xfrm>
            <a:off x="4667862" y="5261240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08F402-68D0-4A95-AFFC-37CD96218811}"/>
              </a:ext>
            </a:extLst>
          </p:cNvPr>
          <p:cNvSpPr txBox="1"/>
          <p:nvPr/>
        </p:nvSpPr>
        <p:spPr>
          <a:xfrm>
            <a:off x="1924453" y="5717400"/>
            <a:ext cx="22271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penia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8EFB54E-7359-490E-AF52-889A222F688E}"/>
              </a:ext>
            </a:extLst>
          </p:cNvPr>
          <p:cNvSpPr txBox="1"/>
          <p:nvPr/>
        </p:nvSpPr>
        <p:spPr>
          <a:xfrm rot="16200000">
            <a:off x="4207472" y="3458122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E373295-49B3-4CF6-B046-0D58332E62CA}"/>
              </a:ext>
            </a:extLst>
          </p:cNvPr>
          <p:cNvSpPr txBox="1"/>
          <p:nvPr/>
        </p:nvSpPr>
        <p:spPr>
          <a:xfrm>
            <a:off x="5464707" y="1493104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DAC067D6-7839-45E5-B939-B494CD5A5D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8382589"/>
              </p:ext>
            </p:extLst>
          </p:nvPr>
        </p:nvGraphicFramePr>
        <p:xfrm>
          <a:off x="5791200" y="1974432"/>
          <a:ext cx="4448226" cy="36501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05A0603-56B5-4CA2-B6AD-FD4132F639BD}"/>
              </a:ext>
            </a:extLst>
          </p:cNvPr>
          <p:cNvSpPr/>
          <p:nvPr/>
        </p:nvSpPr>
        <p:spPr>
          <a:xfrm>
            <a:off x="6146387" y="5250082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8CEB84E-5B23-45D3-8D0D-4A11093806D0}"/>
              </a:ext>
            </a:extLst>
          </p:cNvPr>
          <p:cNvSpPr/>
          <p:nvPr/>
        </p:nvSpPr>
        <p:spPr>
          <a:xfrm>
            <a:off x="9850582" y="5187092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1286745-966A-4815-A09C-18E20B095AD2}"/>
              </a:ext>
            </a:extLst>
          </p:cNvPr>
          <p:cNvSpPr txBox="1"/>
          <p:nvPr/>
        </p:nvSpPr>
        <p:spPr>
          <a:xfrm>
            <a:off x="7081472" y="5764997"/>
            <a:ext cx="20842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utropenia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31ADED2-9C19-4868-A325-4CCBDD60636D}"/>
              </a:ext>
            </a:extLst>
          </p:cNvPr>
          <p:cNvSpPr txBox="1"/>
          <p:nvPr/>
        </p:nvSpPr>
        <p:spPr>
          <a:xfrm>
            <a:off x="3901325" y="151910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80A038E-E3F8-4AC6-BDA9-BD6404309275}"/>
              </a:ext>
            </a:extLst>
          </p:cNvPr>
          <p:cNvSpPr txBox="1"/>
          <p:nvPr/>
        </p:nvSpPr>
        <p:spPr>
          <a:xfrm>
            <a:off x="9056730" y="149539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88964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グラフ 22">
            <a:extLst>
              <a:ext uri="{FF2B5EF4-FFF2-40B4-BE49-F238E27FC236}">
                <a16:creationId xmlns:a16="http://schemas.microsoft.com/office/drawing/2014/main" id="{49396DB2-5E42-43E5-B6EE-AD4C935597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3492421"/>
              </p:ext>
            </p:extLst>
          </p:nvPr>
        </p:nvGraphicFramePr>
        <p:xfrm>
          <a:off x="5889523" y="1954769"/>
          <a:ext cx="4454011" cy="366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グラフ 21">
            <a:extLst>
              <a:ext uri="{FF2B5EF4-FFF2-40B4-BE49-F238E27FC236}">
                <a16:creationId xmlns:a16="http://schemas.microsoft.com/office/drawing/2014/main" id="{033EAA2F-933B-43C4-8E85-506B87C11F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74993684"/>
              </p:ext>
            </p:extLst>
          </p:nvPr>
        </p:nvGraphicFramePr>
        <p:xfrm>
          <a:off x="678593" y="1988174"/>
          <a:ext cx="4353063" cy="3636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A9BD8E-B306-4A66-AAEF-F03B84CCD04A}"/>
              </a:ext>
            </a:extLst>
          </p:cNvPr>
          <p:cNvSpPr txBox="1"/>
          <p:nvPr/>
        </p:nvSpPr>
        <p:spPr>
          <a:xfrm>
            <a:off x="820647" y="257733"/>
            <a:ext cx="762901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</a:t>
            </a:r>
          </a:p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of acute toxicities using </a:t>
            </a:r>
            <a:r>
              <a:rPr lang="el-GR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AX foci decay ratio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A483255-919A-488C-A4E2-133EFEBB82D8}"/>
              </a:ext>
            </a:extLst>
          </p:cNvPr>
          <p:cNvSpPr txBox="1"/>
          <p:nvPr/>
        </p:nvSpPr>
        <p:spPr>
          <a:xfrm rot="16200000">
            <a:off x="-876410" y="3458121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000784-DC8C-4B28-99D1-3DA747ECE237}"/>
              </a:ext>
            </a:extLst>
          </p:cNvPr>
          <p:cNvSpPr txBox="1"/>
          <p:nvPr/>
        </p:nvSpPr>
        <p:spPr>
          <a:xfrm>
            <a:off x="209053" y="1526508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2D31979-B2B6-43FB-A39B-FE141B182F98}"/>
              </a:ext>
            </a:extLst>
          </p:cNvPr>
          <p:cNvSpPr/>
          <p:nvPr/>
        </p:nvSpPr>
        <p:spPr>
          <a:xfrm>
            <a:off x="1071716" y="5261239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9157449-3CDA-46E8-A41E-DA9DD584B071}"/>
              </a:ext>
            </a:extLst>
          </p:cNvPr>
          <p:cNvSpPr/>
          <p:nvPr/>
        </p:nvSpPr>
        <p:spPr>
          <a:xfrm>
            <a:off x="4667862" y="5261240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08F402-68D0-4A95-AFFC-37CD96218811}"/>
              </a:ext>
            </a:extLst>
          </p:cNvPr>
          <p:cNvSpPr txBox="1"/>
          <p:nvPr/>
        </p:nvSpPr>
        <p:spPr>
          <a:xfrm>
            <a:off x="1668470" y="5764997"/>
            <a:ext cx="27671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ombocytopenia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8EFB54E-7359-490E-AF52-889A222F688E}"/>
              </a:ext>
            </a:extLst>
          </p:cNvPr>
          <p:cNvSpPr txBox="1"/>
          <p:nvPr/>
        </p:nvSpPr>
        <p:spPr>
          <a:xfrm rot="16200000">
            <a:off x="4207472" y="3458122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E373295-49B3-4CF6-B046-0D58332E62CA}"/>
              </a:ext>
            </a:extLst>
          </p:cNvPr>
          <p:cNvSpPr txBox="1"/>
          <p:nvPr/>
        </p:nvSpPr>
        <p:spPr>
          <a:xfrm>
            <a:off x="5464707" y="1493104"/>
            <a:ext cx="54373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05A0603-56B5-4CA2-B6AD-FD4132F639BD}"/>
              </a:ext>
            </a:extLst>
          </p:cNvPr>
          <p:cNvSpPr/>
          <p:nvPr/>
        </p:nvSpPr>
        <p:spPr>
          <a:xfrm>
            <a:off x="6284038" y="5159581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8CEB84E-5B23-45D3-8D0D-4A11093806D0}"/>
              </a:ext>
            </a:extLst>
          </p:cNvPr>
          <p:cNvSpPr/>
          <p:nvPr/>
        </p:nvSpPr>
        <p:spPr>
          <a:xfrm>
            <a:off x="9943331" y="5166905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1286745-966A-4815-A09C-18E20B095AD2}"/>
              </a:ext>
            </a:extLst>
          </p:cNvPr>
          <p:cNvSpPr txBox="1"/>
          <p:nvPr/>
        </p:nvSpPr>
        <p:spPr>
          <a:xfrm>
            <a:off x="7483864" y="5764997"/>
            <a:ext cx="15728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usea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31ADED2-9C19-4868-A325-4CCBDD60636D}"/>
              </a:ext>
            </a:extLst>
          </p:cNvPr>
          <p:cNvSpPr txBox="1"/>
          <p:nvPr/>
        </p:nvSpPr>
        <p:spPr>
          <a:xfrm>
            <a:off x="3901325" y="151910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80A038E-E3F8-4AC6-BDA9-BD6404309275}"/>
              </a:ext>
            </a:extLst>
          </p:cNvPr>
          <p:cNvSpPr txBox="1"/>
          <p:nvPr/>
        </p:nvSpPr>
        <p:spPr>
          <a:xfrm>
            <a:off x="9056730" y="149539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610351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グラフ 24">
            <a:extLst>
              <a:ext uri="{FF2B5EF4-FFF2-40B4-BE49-F238E27FC236}">
                <a16:creationId xmlns:a16="http://schemas.microsoft.com/office/drawing/2014/main" id="{80358027-B0E7-48A7-B6FE-5251A65EAA7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2453828"/>
              </p:ext>
            </p:extLst>
          </p:nvPr>
        </p:nvGraphicFramePr>
        <p:xfrm>
          <a:off x="5957150" y="1912582"/>
          <a:ext cx="4168078" cy="40285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4" name="グラフ 23">
            <a:extLst>
              <a:ext uri="{FF2B5EF4-FFF2-40B4-BE49-F238E27FC236}">
                <a16:creationId xmlns:a16="http://schemas.microsoft.com/office/drawing/2014/main" id="{B35A7FC2-D7E5-4898-AE97-6D6C47A9D2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63700781"/>
              </p:ext>
            </p:extLst>
          </p:nvPr>
        </p:nvGraphicFramePr>
        <p:xfrm>
          <a:off x="724366" y="1912582"/>
          <a:ext cx="4373549" cy="40285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A9BD8E-B306-4A66-AAEF-F03B84CCD04A}"/>
              </a:ext>
            </a:extLst>
          </p:cNvPr>
          <p:cNvSpPr txBox="1"/>
          <p:nvPr/>
        </p:nvSpPr>
        <p:spPr>
          <a:xfrm>
            <a:off x="820647" y="257733"/>
            <a:ext cx="762901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</a:t>
            </a:r>
          </a:p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of acute toxicities using </a:t>
            </a:r>
            <a:r>
              <a:rPr lang="el-GR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γ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2AX foci decay ratio</a:t>
            </a: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A483255-919A-488C-A4E2-133EFEBB82D8}"/>
              </a:ext>
            </a:extLst>
          </p:cNvPr>
          <p:cNvSpPr txBox="1"/>
          <p:nvPr/>
        </p:nvSpPr>
        <p:spPr>
          <a:xfrm rot="16200000">
            <a:off x="-911125" y="3579782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000784-DC8C-4B28-99D1-3DA747ECE237}"/>
              </a:ext>
            </a:extLst>
          </p:cNvPr>
          <p:cNvSpPr txBox="1"/>
          <p:nvPr/>
        </p:nvSpPr>
        <p:spPr>
          <a:xfrm>
            <a:off x="209053" y="1526508"/>
            <a:ext cx="5261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2D31979-B2B6-43FB-A39B-FE141B182F98}"/>
              </a:ext>
            </a:extLst>
          </p:cNvPr>
          <p:cNvSpPr/>
          <p:nvPr/>
        </p:nvSpPr>
        <p:spPr>
          <a:xfrm>
            <a:off x="1076181" y="5439437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9157449-3CDA-46E8-A41E-DA9DD584B071}"/>
              </a:ext>
            </a:extLst>
          </p:cNvPr>
          <p:cNvSpPr/>
          <p:nvPr/>
        </p:nvSpPr>
        <p:spPr>
          <a:xfrm>
            <a:off x="4755040" y="5400074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08F402-68D0-4A95-AFFC-37CD96218811}"/>
              </a:ext>
            </a:extLst>
          </p:cNvPr>
          <p:cNvSpPr txBox="1"/>
          <p:nvPr/>
        </p:nvSpPr>
        <p:spPr>
          <a:xfrm>
            <a:off x="1973686" y="5800205"/>
            <a:ext cx="17139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rrhea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8EFB54E-7359-490E-AF52-889A222F688E}"/>
              </a:ext>
            </a:extLst>
          </p:cNvPr>
          <p:cNvSpPr txBox="1"/>
          <p:nvPr/>
        </p:nvSpPr>
        <p:spPr>
          <a:xfrm rot="16200000">
            <a:off x="4207472" y="3458122"/>
            <a:ext cx="26404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γH2AX foci decay ratio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E373295-49B3-4CF6-B046-0D58332E62CA}"/>
              </a:ext>
            </a:extLst>
          </p:cNvPr>
          <p:cNvSpPr txBox="1"/>
          <p:nvPr/>
        </p:nvSpPr>
        <p:spPr>
          <a:xfrm>
            <a:off x="5464707" y="1493104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605A0603-56B5-4CA2-B6AD-FD4132F639BD}"/>
              </a:ext>
            </a:extLst>
          </p:cNvPr>
          <p:cNvSpPr/>
          <p:nvPr/>
        </p:nvSpPr>
        <p:spPr>
          <a:xfrm>
            <a:off x="6474974" y="5432109"/>
            <a:ext cx="315858" cy="4448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48CEB84E-5B23-45D3-8D0D-4A11093806D0}"/>
              </a:ext>
            </a:extLst>
          </p:cNvPr>
          <p:cNvSpPr/>
          <p:nvPr/>
        </p:nvSpPr>
        <p:spPr>
          <a:xfrm>
            <a:off x="9930934" y="5410616"/>
            <a:ext cx="363794" cy="4374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1286745-966A-4815-A09C-18E20B095AD2}"/>
              </a:ext>
            </a:extLst>
          </p:cNvPr>
          <p:cNvSpPr txBox="1"/>
          <p:nvPr/>
        </p:nvSpPr>
        <p:spPr>
          <a:xfrm>
            <a:off x="7483864" y="5764997"/>
            <a:ext cx="15985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stitis grade</a:t>
            </a:r>
            <a:endParaRPr lang="en-US" altLang="ja-JP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31ADED2-9C19-4868-A325-4CCBDD60636D}"/>
              </a:ext>
            </a:extLst>
          </p:cNvPr>
          <p:cNvSpPr txBox="1"/>
          <p:nvPr/>
        </p:nvSpPr>
        <p:spPr>
          <a:xfrm>
            <a:off x="3901325" y="151910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80A038E-E3F8-4AC6-BDA9-BD6404309275}"/>
              </a:ext>
            </a:extLst>
          </p:cNvPr>
          <p:cNvSpPr txBox="1"/>
          <p:nvPr/>
        </p:nvSpPr>
        <p:spPr>
          <a:xfrm>
            <a:off x="9056730" y="1495399"/>
            <a:ext cx="1068498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●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RT</a:t>
            </a:r>
          </a:p>
          <a:p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〇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:CCRT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31275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68</TotalTime>
  <Words>204</Words>
  <Application>Microsoft Office PowerPoint</Application>
  <PresentationFormat>ユーザー設定</PresentationFormat>
  <Paragraphs>59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4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染谷正則</dc:creator>
  <cp:lastModifiedBy>染谷正則</cp:lastModifiedBy>
  <cp:revision>57</cp:revision>
  <dcterms:created xsi:type="dcterms:W3CDTF">2022-12-13T07:07:30Z</dcterms:created>
  <dcterms:modified xsi:type="dcterms:W3CDTF">2023-09-19T23:38:48Z</dcterms:modified>
</cp:coreProperties>
</file>